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792913" cy="99329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B00637-6986-4454-ADD8-BD5836C7C99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753937-C2CC-4626-A87C-EBD1F1B6794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D52318-6784-4165-923F-0710976F934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9973BB-AB06-4BA4-84A1-14B67F83238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5AC50F-C1CA-4F37-A1F7-107DB524C8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77B54E-0ADC-494D-94BF-4D8F508BED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A84477-DFC6-4ABB-92F5-D1ACB57E85F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081414-07F1-48F1-82C4-A54054D5673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30C1BE-07CB-44CA-B421-9D0F04DCDAF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DCA76D-A640-4169-91DB-6E5EE3170B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176E8E-E0FA-445A-BA3F-5213FE793A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24DE2A-84F6-419E-B6D1-6D3355C86B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6C935F1-54A8-4EE6-8CF8-C541C1036B5F}" type="datetime">
              <a:rPr b="0" lang="ja-JP" sz="1200" spc="-1" strike="noStrike">
                <a:solidFill>
                  <a:srgbClr val="898989"/>
                </a:solidFill>
                <a:latin typeface="Calibri"/>
              </a:rPr>
              <a:t>26/08/29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710ADC4-1A92-4114-AED7-EC98A01CE53D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図 8" descr=""/>
          <p:cNvPicPr/>
          <p:nvPr/>
        </p:nvPicPr>
        <p:blipFill>
          <a:blip r:embed="rId1"/>
          <a:srcRect l="9432" t="25937" r="41762" b="67457"/>
          <a:stretch/>
        </p:blipFill>
        <p:spPr>
          <a:xfrm>
            <a:off x="1650960" y="2448000"/>
            <a:ext cx="4299120" cy="495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2" name="図 9" descr=""/>
          <p:cNvPicPr/>
          <p:nvPr/>
        </p:nvPicPr>
        <p:blipFill>
          <a:blip r:embed="rId2"/>
          <a:srcRect l="11291" t="19960" r="39906" b="62069"/>
          <a:stretch/>
        </p:blipFill>
        <p:spPr>
          <a:xfrm>
            <a:off x="1650960" y="2992320"/>
            <a:ext cx="4299120" cy="1349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3" name="テキスト ボックス 37"/>
          <p:cNvSpPr/>
          <p:nvPr/>
        </p:nvSpPr>
        <p:spPr>
          <a:xfrm>
            <a:off x="1768680" y="1477800"/>
            <a:ext cx="916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Input (5%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テキスト ボックス 38"/>
          <p:cNvSpPr/>
          <p:nvPr/>
        </p:nvSpPr>
        <p:spPr>
          <a:xfrm>
            <a:off x="2658960" y="1465200"/>
            <a:ext cx="738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α-FLA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テキスト ボックス 39"/>
          <p:cNvSpPr/>
          <p:nvPr/>
        </p:nvSpPr>
        <p:spPr>
          <a:xfrm>
            <a:off x="3468240" y="1457280"/>
            <a:ext cx="732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α-Spik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テキスト ボックス 40"/>
          <p:cNvSpPr/>
          <p:nvPr/>
        </p:nvSpPr>
        <p:spPr>
          <a:xfrm rot="16200000">
            <a:off x="1729080" y="1971360"/>
            <a:ext cx="5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EGF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テキスト ボックス 41"/>
          <p:cNvSpPr/>
          <p:nvPr/>
        </p:nvSpPr>
        <p:spPr>
          <a:xfrm rot="16200000">
            <a:off x="2076120" y="2050200"/>
            <a:ext cx="435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Vp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テキスト ボックス 42"/>
          <p:cNvSpPr/>
          <p:nvPr/>
        </p:nvSpPr>
        <p:spPr>
          <a:xfrm rot="16200000">
            <a:off x="2570400" y="1981800"/>
            <a:ext cx="5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EGF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テキスト ボックス 43"/>
          <p:cNvSpPr/>
          <p:nvPr/>
        </p:nvSpPr>
        <p:spPr>
          <a:xfrm rot="16200000">
            <a:off x="2917800" y="2060640"/>
            <a:ext cx="435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Vp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テキスト ボックス 44"/>
          <p:cNvSpPr/>
          <p:nvPr/>
        </p:nvSpPr>
        <p:spPr>
          <a:xfrm rot="16200000">
            <a:off x="3402000" y="1971360"/>
            <a:ext cx="5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EGF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テキスト ボックス 45"/>
          <p:cNvSpPr/>
          <p:nvPr/>
        </p:nvSpPr>
        <p:spPr>
          <a:xfrm rot="16200000">
            <a:off x="3749400" y="2050200"/>
            <a:ext cx="435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Vp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直線コネクタ 14"/>
          <p:cNvSpPr/>
          <p:nvPr/>
        </p:nvSpPr>
        <p:spPr>
          <a:xfrm>
            <a:off x="2730600" y="1795320"/>
            <a:ext cx="544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直線コネクタ 15"/>
          <p:cNvSpPr/>
          <p:nvPr/>
        </p:nvSpPr>
        <p:spPr>
          <a:xfrm>
            <a:off x="3562200" y="1795320"/>
            <a:ext cx="544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直線コネクタ 16"/>
          <p:cNvSpPr/>
          <p:nvPr/>
        </p:nvSpPr>
        <p:spPr>
          <a:xfrm>
            <a:off x="1930320" y="1795320"/>
            <a:ext cx="544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テキスト ボックス 49"/>
          <p:cNvSpPr/>
          <p:nvPr/>
        </p:nvSpPr>
        <p:spPr>
          <a:xfrm>
            <a:off x="4278240" y="1465200"/>
            <a:ext cx="738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α-FLA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テキスト ボックス 50"/>
          <p:cNvSpPr/>
          <p:nvPr/>
        </p:nvSpPr>
        <p:spPr>
          <a:xfrm>
            <a:off x="5087520" y="1457280"/>
            <a:ext cx="732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α-Spik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テキスト ボックス 51"/>
          <p:cNvSpPr/>
          <p:nvPr/>
        </p:nvSpPr>
        <p:spPr>
          <a:xfrm rot="16200000">
            <a:off x="4189680" y="1981800"/>
            <a:ext cx="5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EGF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テキスト ボックス 52"/>
          <p:cNvSpPr/>
          <p:nvPr/>
        </p:nvSpPr>
        <p:spPr>
          <a:xfrm rot="16200000">
            <a:off x="4536720" y="2060640"/>
            <a:ext cx="435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Vp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テキスト ボックス 53"/>
          <p:cNvSpPr/>
          <p:nvPr/>
        </p:nvSpPr>
        <p:spPr>
          <a:xfrm rot="16200000">
            <a:off x="5021280" y="1971360"/>
            <a:ext cx="5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EGF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テキスト ボックス 54"/>
          <p:cNvSpPr/>
          <p:nvPr/>
        </p:nvSpPr>
        <p:spPr>
          <a:xfrm rot="16200000">
            <a:off x="5368680" y="2050200"/>
            <a:ext cx="435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Vp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直線コネクタ 23"/>
          <p:cNvSpPr/>
          <p:nvPr/>
        </p:nvSpPr>
        <p:spPr>
          <a:xfrm>
            <a:off x="4349880" y="1795320"/>
            <a:ext cx="544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直線コネクタ 24"/>
          <p:cNvSpPr/>
          <p:nvPr/>
        </p:nvSpPr>
        <p:spPr>
          <a:xfrm>
            <a:off x="5181480" y="1795320"/>
            <a:ext cx="544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テキスト ボックス 57"/>
          <p:cNvSpPr/>
          <p:nvPr/>
        </p:nvSpPr>
        <p:spPr>
          <a:xfrm>
            <a:off x="378000" y="297000"/>
            <a:ext cx="2736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 Unicode MS"/>
              </a:rPr>
              <a:t>Supplementary Figure S1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テキスト ボックス 58"/>
          <p:cNvSpPr/>
          <p:nvPr/>
        </p:nvSpPr>
        <p:spPr>
          <a:xfrm>
            <a:off x="807480" y="2651040"/>
            <a:ext cx="695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IB:Ah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テキスト ボックス 59"/>
          <p:cNvSpPr/>
          <p:nvPr/>
        </p:nvSpPr>
        <p:spPr>
          <a:xfrm>
            <a:off x="808920" y="3517920"/>
            <a:ext cx="798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IB:FLA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直線コネクタ 29"/>
          <p:cNvSpPr/>
          <p:nvPr/>
        </p:nvSpPr>
        <p:spPr>
          <a:xfrm>
            <a:off x="2735280" y="1376280"/>
            <a:ext cx="1371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直線コネクタ 30"/>
          <p:cNvSpPr/>
          <p:nvPr/>
        </p:nvSpPr>
        <p:spPr>
          <a:xfrm>
            <a:off x="4343400" y="1366920"/>
            <a:ext cx="1371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テキスト ボックス 68"/>
          <p:cNvSpPr/>
          <p:nvPr/>
        </p:nvSpPr>
        <p:spPr>
          <a:xfrm>
            <a:off x="2768040" y="1065240"/>
            <a:ext cx="136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IP (-) Benzona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テキスト ボックス 69"/>
          <p:cNvSpPr/>
          <p:nvPr/>
        </p:nvSpPr>
        <p:spPr>
          <a:xfrm>
            <a:off x="4320720" y="1065240"/>
            <a:ext cx="1406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IP (+) Benzona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0" name="図 3" descr=""/>
          <p:cNvPicPr/>
          <p:nvPr/>
        </p:nvPicPr>
        <p:blipFill>
          <a:blip r:embed="rId3"/>
          <a:srcRect l="14963" t="45311" r="38541" b="41699"/>
          <a:stretch/>
        </p:blipFill>
        <p:spPr>
          <a:xfrm>
            <a:off x="1824120" y="6369120"/>
            <a:ext cx="4043160" cy="9079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71" name="図 4" descr=""/>
          <p:cNvPicPr/>
          <p:nvPr/>
        </p:nvPicPr>
        <p:blipFill>
          <a:blip r:embed="rId4"/>
          <a:srcRect l="14698" t="27844" r="38810" b="59747"/>
          <a:stretch/>
        </p:blipFill>
        <p:spPr>
          <a:xfrm>
            <a:off x="1824120" y="7337520"/>
            <a:ext cx="4043160" cy="8665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72" name="テキスト ボックス 5"/>
          <p:cNvSpPr/>
          <p:nvPr/>
        </p:nvSpPr>
        <p:spPr>
          <a:xfrm>
            <a:off x="3259080" y="5229360"/>
            <a:ext cx="714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α-Ah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テキスト ボックス 6"/>
          <p:cNvSpPr/>
          <p:nvPr/>
        </p:nvSpPr>
        <p:spPr>
          <a:xfrm>
            <a:off x="4828320" y="5229360"/>
            <a:ext cx="478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Ig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テキスト ボックス 7"/>
          <p:cNvSpPr/>
          <p:nvPr/>
        </p:nvSpPr>
        <p:spPr>
          <a:xfrm>
            <a:off x="1992600" y="5788080"/>
            <a:ext cx="923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5% Inpu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テキスト ボックス 8"/>
          <p:cNvSpPr/>
          <p:nvPr/>
        </p:nvSpPr>
        <p:spPr>
          <a:xfrm>
            <a:off x="3181680" y="5826240"/>
            <a:ext cx="1040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(-) (+)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テキスト ボックス 9"/>
          <p:cNvSpPr/>
          <p:nvPr/>
        </p:nvSpPr>
        <p:spPr>
          <a:xfrm>
            <a:off x="4556520" y="5827680"/>
            <a:ext cx="1040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(-) (+)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直線コネクタ 57"/>
          <p:cNvSpPr/>
          <p:nvPr/>
        </p:nvSpPr>
        <p:spPr>
          <a:xfrm>
            <a:off x="3230640" y="5595840"/>
            <a:ext cx="846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直線コネクタ 58"/>
          <p:cNvSpPr/>
          <p:nvPr/>
        </p:nvSpPr>
        <p:spPr>
          <a:xfrm>
            <a:off x="4599000" y="5595840"/>
            <a:ext cx="846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テキスト ボックス 12"/>
          <p:cNvSpPr/>
          <p:nvPr/>
        </p:nvSpPr>
        <p:spPr>
          <a:xfrm>
            <a:off x="3092040" y="5597640"/>
            <a:ext cx="1119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enzonas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テキスト ボックス 13"/>
          <p:cNvSpPr/>
          <p:nvPr/>
        </p:nvSpPr>
        <p:spPr>
          <a:xfrm>
            <a:off x="4490640" y="5597640"/>
            <a:ext cx="1119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enzonas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テキスト ボックス 14"/>
          <p:cNvSpPr/>
          <p:nvPr/>
        </p:nvSpPr>
        <p:spPr>
          <a:xfrm>
            <a:off x="811080" y="6675480"/>
            <a:ext cx="782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IB:Ah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テキスト ボックス 15"/>
          <p:cNvSpPr/>
          <p:nvPr/>
        </p:nvSpPr>
        <p:spPr>
          <a:xfrm>
            <a:off x="811080" y="7574040"/>
            <a:ext cx="903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IB:EGF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テキスト ボックス 15"/>
          <p:cNvSpPr/>
          <p:nvPr/>
        </p:nvSpPr>
        <p:spPr>
          <a:xfrm>
            <a:off x="596160" y="515304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テキスト ボックス 5"/>
          <p:cNvSpPr/>
          <p:nvPr/>
        </p:nvSpPr>
        <p:spPr>
          <a:xfrm>
            <a:off x="4110480" y="4803840"/>
            <a:ext cx="349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I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直線コネクタ 66"/>
          <p:cNvSpPr/>
          <p:nvPr/>
        </p:nvSpPr>
        <p:spPr>
          <a:xfrm>
            <a:off x="3214800" y="5168880"/>
            <a:ext cx="224784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テキスト ボックス 15"/>
          <p:cNvSpPr/>
          <p:nvPr/>
        </p:nvSpPr>
        <p:spPr>
          <a:xfrm>
            <a:off x="545400" y="91440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テキスト ボックス 1"/>
          <p:cNvSpPr/>
          <p:nvPr/>
        </p:nvSpPr>
        <p:spPr>
          <a:xfrm>
            <a:off x="212760" y="8337600"/>
            <a:ext cx="6553080" cy="142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Supplementary Figure S15. Effects of nuclease on the interaction of AhR and Vpr or  ORF1.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(A) HEK293T cells were transfected with FLAG-EGFP or FLAG-Vpr expression vectors. After 2 days, cells were subjected to IP-WB experiments as described  in materials and methods, excepts 1.5 mM of MgCl</a:t>
            </a:r>
            <a:r>
              <a:rPr b="1" lang="en-US" sz="1200" spc="-1" strike="noStrike" baseline="-25000">
                <a:solidFill>
                  <a:srgbClr val="000000"/>
                </a:solidFill>
                <a:latin typeface="Arial"/>
                <a:ea typeface="Arial Unicode MS"/>
              </a:rPr>
              <a:t>2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 and Benzonase was included in IP reaction. (B) HuH-7 cells  were transfected with ORF1-EGFP expression vector and samples were prepared as in (A) but 2.5 mM of MgCl</a:t>
            </a:r>
            <a:r>
              <a:rPr b="1" lang="en-US" sz="1200" spc="-1" strike="noStrike" baseline="-25000">
                <a:solidFill>
                  <a:srgbClr val="000000"/>
                </a:solidFill>
                <a:latin typeface="Arial"/>
                <a:ea typeface="Arial Unicode MS"/>
              </a:rPr>
              <a:t>2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 was included. In each cases, nuclease treatments did not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disrupt the any protein-protein interaction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70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6-12T00:59:02Z</dcterms:created>
  <dc:creator>奥平准之</dc:creator>
  <dc:description/>
  <dc:language>en-US</dc:language>
  <cp:lastModifiedBy>Santos, Noribeth</cp:lastModifiedBy>
  <cp:lastPrinted>2013-06-12T04:06:08Z</cp:lastPrinted>
  <dcterms:modified xsi:type="dcterms:W3CDTF">2013-06-14T07:57:52Z</dcterms:modified>
  <cp:revision>1634</cp:revision>
  <dc:subject/>
  <dc:title>スライド 1</dc:title>
</cp:coreProperties>
</file>